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6.jpeg" ContentType="image/jpeg"/>
  <Override PartName="/ppt/media/image8.png" ContentType="image/png"/>
  <Override PartName="/ppt/media/image7.png" ContentType="image/png"/>
  <Override PartName="/ppt/media/image9.png" ContentType="image/png"/>
  <Override PartName="/ppt/media/image10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09BB5A-C3AE-4D82-AB04-1271FF99DE1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5A01D7-FB8D-4A8C-B1DB-B4709FE702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C628FB-CE18-4322-AC52-F38DB4A1706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AE1340-BD48-4536-B1FE-0EF591AEBAD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F55214-4F6F-4837-9FC8-097383F58D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911F34-ED40-4ED1-BEFD-55E9173BDB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BC53DC-0710-4304-A601-ADB8E2A82F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35FEE0-F54D-4638-A56B-E6521EDEB5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BD937E-CEC5-47C8-96EE-6504C79AA6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798357-70B0-4FEA-B1C0-D20D8F193B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AAB3B0-9B1B-42AF-9361-C271FA413A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847FCA-4162-47D0-A26A-E7F31679F9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FCF3A2A-6B8D-48CA-AE7B-BD148186B83B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wmf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296640" y="26028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Line 258"/>
          <p:cNvSpPr/>
          <p:nvPr/>
        </p:nvSpPr>
        <p:spPr>
          <a:xfrm>
            <a:off x="863640" y="1073160"/>
            <a:ext cx="5283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Text Box 259"/>
          <p:cNvSpPr/>
          <p:nvPr/>
        </p:nvSpPr>
        <p:spPr>
          <a:xfrm>
            <a:off x="709560" y="746280"/>
            <a:ext cx="371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5’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Text Box 260"/>
          <p:cNvSpPr/>
          <p:nvPr/>
        </p:nvSpPr>
        <p:spPr>
          <a:xfrm>
            <a:off x="6043680" y="746280"/>
            <a:ext cx="371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3’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Text Box 261"/>
          <p:cNvSpPr/>
          <p:nvPr/>
        </p:nvSpPr>
        <p:spPr>
          <a:xfrm>
            <a:off x="747720" y="108756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TG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Text Box 262"/>
          <p:cNvSpPr/>
          <p:nvPr/>
        </p:nvSpPr>
        <p:spPr>
          <a:xfrm>
            <a:off x="5753160" y="1087560"/>
            <a:ext cx="65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AA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Line 263"/>
          <p:cNvSpPr/>
          <p:nvPr/>
        </p:nvSpPr>
        <p:spPr>
          <a:xfrm>
            <a:off x="3414600" y="1233360"/>
            <a:ext cx="1231920" cy="0"/>
          </a:xfrm>
          <a:prstGeom prst="line">
            <a:avLst/>
          </a:prstGeom>
          <a:ln w="2844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Line 264"/>
          <p:cNvSpPr/>
          <p:nvPr/>
        </p:nvSpPr>
        <p:spPr>
          <a:xfrm>
            <a:off x="4686480" y="927000"/>
            <a:ext cx="1054080" cy="0"/>
          </a:xfrm>
          <a:prstGeom prst="line">
            <a:avLst/>
          </a:prstGeom>
          <a:ln w="2844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Line 265"/>
          <p:cNvSpPr/>
          <p:nvPr/>
        </p:nvSpPr>
        <p:spPr>
          <a:xfrm>
            <a:off x="1027080" y="912960"/>
            <a:ext cx="2224080" cy="0"/>
          </a:xfrm>
          <a:prstGeom prst="line">
            <a:avLst/>
          </a:prstGeom>
          <a:ln w="2844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Text Box 266"/>
          <p:cNvSpPr/>
          <p:nvPr/>
        </p:nvSpPr>
        <p:spPr>
          <a:xfrm>
            <a:off x="1571040" y="282600"/>
            <a:ext cx="1134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5’ probe 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890 pb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Text Box 267"/>
          <p:cNvSpPr/>
          <p:nvPr/>
        </p:nvSpPr>
        <p:spPr>
          <a:xfrm>
            <a:off x="3353040" y="1233360"/>
            <a:ext cx="14151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GST probe 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501 pb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Text Box 268"/>
          <p:cNvSpPr/>
          <p:nvPr/>
        </p:nvSpPr>
        <p:spPr>
          <a:xfrm>
            <a:off x="4690440" y="311040"/>
            <a:ext cx="10706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3’ probe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368 pb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Rectangle 454"/>
          <p:cNvSpPr/>
          <p:nvPr/>
        </p:nvSpPr>
        <p:spPr>
          <a:xfrm rot="16200000">
            <a:off x="3203640" y="8256240"/>
            <a:ext cx="36504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54" name="Group 282"/>
          <p:cNvGrpSpPr/>
          <p:nvPr/>
        </p:nvGrpSpPr>
        <p:grpSpPr>
          <a:xfrm>
            <a:off x="2901960" y="2268360"/>
            <a:ext cx="1657440" cy="1050480"/>
            <a:chOff x="2901960" y="2268360"/>
            <a:chExt cx="1657440" cy="1050480"/>
          </a:xfrm>
        </p:grpSpPr>
        <p:pic>
          <p:nvPicPr>
            <p:cNvPr id="55" name="Picture 3" descr=""/>
            <p:cNvPicPr/>
            <p:nvPr/>
          </p:nvPicPr>
          <p:blipFill>
            <a:blip r:embed="rId1">
              <a:lum contrast="18000"/>
            </a:blip>
            <a:srcRect l="12791" t="42989" r="19775" b="33139"/>
            <a:stretch/>
          </p:blipFill>
          <p:spPr>
            <a:xfrm>
              <a:off x="2901960" y="2302200"/>
              <a:ext cx="1657440" cy="1016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Line 46"/>
            <p:cNvSpPr/>
            <p:nvPr/>
          </p:nvSpPr>
          <p:spPr>
            <a:xfrm>
              <a:off x="3244680" y="2268360"/>
              <a:ext cx="1257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57" name="Group 281"/>
          <p:cNvGrpSpPr/>
          <p:nvPr/>
        </p:nvGrpSpPr>
        <p:grpSpPr>
          <a:xfrm>
            <a:off x="711360" y="1976400"/>
            <a:ext cx="1712880" cy="1350720"/>
            <a:chOff x="711360" y="1976400"/>
            <a:chExt cx="1712880" cy="1350720"/>
          </a:xfrm>
        </p:grpSpPr>
        <p:pic>
          <p:nvPicPr>
            <p:cNvPr id="58" name="Picture 251" descr=""/>
            <p:cNvPicPr/>
            <p:nvPr/>
          </p:nvPicPr>
          <p:blipFill>
            <a:blip r:embed="rId2"/>
            <a:srcRect l="11218" t="48438" r="18739" b="28514"/>
            <a:stretch/>
          </p:blipFill>
          <p:spPr>
            <a:xfrm>
              <a:off x="711360" y="2304360"/>
              <a:ext cx="1665720" cy="1022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9" name="Text Box 252"/>
            <p:cNvSpPr/>
            <p:nvPr/>
          </p:nvSpPr>
          <p:spPr>
            <a:xfrm>
              <a:off x="996840" y="1976400"/>
              <a:ext cx="1427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2   4    8  12  20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Line 253"/>
            <p:cNvSpPr/>
            <p:nvPr/>
          </p:nvSpPr>
          <p:spPr>
            <a:xfrm>
              <a:off x="1002960" y="2261880"/>
              <a:ext cx="1333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Text Box 254"/>
            <p:cNvSpPr/>
            <p:nvPr/>
          </p:nvSpPr>
          <p:spPr>
            <a:xfrm>
              <a:off x="739800" y="197640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62" name="Group 280"/>
          <p:cNvGrpSpPr/>
          <p:nvPr/>
        </p:nvGrpSpPr>
        <p:grpSpPr>
          <a:xfrm>
            <a:off x="4943520" y="2266920"/>
            <a:ext cx="1654200" cy="1060200"/>
            <a:chOff x="4943520" y="2266920"/>
            <a:chExt cx="1654200" cy="1060200"/>
          </a:xfrm>
        </p:grpSpPr>
        <p:pic>
          <p:nvPicPr>
            <p:cNvPr id="63" name="Picture 250" descr=""/>
            <p:cNvPicPr/>
            <p:nvPr/>
          </p:nvPicPr>
          <p:blipFill>
            <a:blip r:embed="rId3"/>
            <a:srcRect l="3902" t="49739" r="4811" b="30736"/>
            <a:stretch/>
          </p:blipFill>
          <p:spPr>
            <a:xfrm>
              <a:off x="4943520" y="2307240"/>
              <a:ext cx="1654200" cy="1019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4" name="Line 256"/>
            <p:cNvSpPr/>
            <p:nvPr/>
          </p:nvSpPr>
          <p:spPr>
            <a:xfrm>
              <a:off x="5290920" y="2266920"/>
              <a:ext cx="125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65" name="Text Box 288"/>
          <p:cNvSpPr/>
          <p:nvPr/>
        </p:nvSpPr>
        <p:spPr>
          <a:xfrm>
            <a:off x="253800" y="173988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Text Box 415"/>
          <p:cNvSpPr/>
          <p:nvPr/>
        </p:nvSpPr>
        <p:spPr>
          <a:xfrm>
            <a:off x="1013760" y="3351240"/>
            <a:ext cx="1134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5’ probe 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890 pb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Text Box 416"/>
          <p:cNvSpPr/>
          <p:nvPr/>
        </p:nvSpPr>
        <p:spPr>
          <a:xfrm>
            <a:off x="3022920" y="3351240"/>
            <a:ext cx="14151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GST probe 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501 pb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Text Box 417"/>
          <p:cNvSpPr/>
          <p:nvPr/>
        </p:nvSpPr>
        <p:spPr>
          <a:xfrm>
            <a:off x="5312880" y="3351240"/>
            <a:ext cx="10706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3’ probe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368 pb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Text Box 488"/>
          <p:cNvSpPr/>
          <p:nvPr/>
        </p:nvSpPr>
        <p:spPr>
          <a:xfrm>
            <a:off x="110880" y="2538360"/>
            <a:ext cx="57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1 nt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Line 489"/>
          <p:cNvSpPr/>
          <p:nvPr/>
        </p:nvSpPr>
        <p:spPr>
          <a:xfrm>
            <a:off x="558720" y="2716200"/>
            <a:ext cx="1652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Line 491"/>
          <p:cNvSpPr/>
          <p:nvPr/>
        </p:nvSpPr>
        <p:spPr>
          <a:xfrm>
            <a:off x="2679840" y="2728800"/>
            <a:ext cx="1666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Line 492"/>
          <p:cNvSpPr/>
          <p:nvPr/>
        </p:nvSpPr>
        <p:spPr>
          <a:xfrm>
            <a:off x="4762440" y="2728800"/>
            <a:ext cx="1652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Text Box 252"/>
          <p:cNvSpPr/>
          <p:nvPr/>
        </p:nvSpPr>
        <p:spPr>
          <a:xfrm>
            <a:off x="3176640" y="1987560"/>
            <a:ext cx="142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   4    8  12  2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Text Box 254"/>
          <p:cNvSpPr/>
          <p:nvPr/>
        </p:nvSpPr>
        <p:spPr>
          <a:xfrm>
            <a:off x="2894400" y="198756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Text Box 252"/>
          <p:cNvSpPr/>
          <p:nvPr/>
        </p:nvSpPr>
        <p:spPr>
          <a:xfrm>
            <a:off x="5219640" y="2008080"/>
            <a:ext cx="142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   4    8  12  2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Text Box 254"/>
          <p:cNvSpPr/>
          <p:nvPr/>
        </p:nvSpPr>
        <p:spPr>
          <a:xfrm>
            <a:off x="4964400" y="20080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Text Box 53"/>
          <p:cNvSpPr/>
          <p:nvPr/>
        </p:nvSpPr>
        <p:spPr>
          <a:xfrm>
            <a:off x="425520" y="7567560"/>
            <a:ext cx="63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robe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8" name="Picture 57" descr="BULK si5'-JC"/>
          <p:cNvPicPr/>
          <p:nvPr/>
        </p:nvPicPr>
        <p:blipFill>
          <a:blip r:embed="rId4"/>
          <a:srcRect l="2578" t="47616" r="70217" b="33471"/>
          <a:stretch/>
        </p:blipFill>
        <p:spPr>
          <a:xfrm>
            <a:off x="936720" y="8283600"/>
            <a:ext cx="1162080" cy="5619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9" name="Picture 58" descr="mb elo 82 Si11"/>
          <p:cNvPicPr/>
          <p:nvPr/>
        </p:nvPicPr>
        <p:blipFill>
          <a:blip r:embed="rId5"/>
          <a:srcRect l="11379" t="51389" r="58959" b="32300"/>
          <a:stretch/>
        </p:blipFill>
        <p:spPr>
          <a:xfrm>
            <a:off x="2108160" y="8283600"/>
            <a:ext cx="638280" cy="5634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0" name="Text Box 60"/>
          <p:cNvSpPr/>
          <p:nvPr/>
        </p:nvSpPr>
        <p:spPr>
          <a:xfrm>
            <a:off x="1285560" y="7929720"/>
            <a:ext cx="78120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700" spc="-1" strike="noStrike">
                <a:solidFill>
                  <a:srgbClr val="000000"/>
                </a:solidFill>
                <a:latin typeface="Arial"/>
              </a:rPr>
              <a:t>10  30</a:t>
            </a: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Text Box 61"/>
          <p:cNvSpPr/>
          <p:nvPr/>
        </p:nvSpPr>
        <p:spPr>
          <a:xfrm>
            <a:off x="950400" y="7929720"/>
            <a:ext cx="33768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7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Text Box 62"/>
          <p:cNvSpPr/>
          <p:nvPr/>
        </p:nvSpPr>
        <p:spPr>
          <a:xfrm>
            <a:off x="2118600" y="7929720"/>
            <a:ext cx="33768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7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Text Box 63"/>
          <p:cNvSpPr/>
          <p:nvPr/>
        </p:nvSpPr>
        <p:spPr>
          <a:xfrm>
            <a:off x="2403360" y="7929720"/>
            <a:ext cx="36072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7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84" name="Picture 65" descr="Bulk si5' mb Nb0-10-30"/>
          <p:cNvPicPr/>
          <p:nvPr/>
        </p:nvPicPr>
        <p:blipFill>
          <a:blip r:embed="rId6"/>
          <a:stretch/>
        </p:blipFill>
        <p:spPr>
          <a:xfrm>
            <a:off x="4756320" y="8285040"/>
            <a:ext cx="1169640" cy="5637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5" name="Picture 66" descr="BULK si3'-elo"/>
          <p:cNvPicPr/>
          <p:nvPr/>
        </p:nvPicPr>
        <p:blipFill>
          <a:blip r:embed="rId7"/>
          <a:srcRect l="33367" t="44988" r="33283" b="37488"/>
          <a:stretch/>
        </p:blipFill>
        <p:spPr>
          <a:xfrm>
            <a:off x="5925960" y="8283600"/>
            <a:ext cx="641520" cy="565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pSp>
        <p:nvGrpSpPr>
          <p:cNvPr id="86" name="Group 67"/>
          <p:cNvGrpSpPr/>
          <p:nvPr/>
        </p:nvGrpSpPr>
        <p:grpSpPr>
          <a:xfrm>
            <a:off x="4767840" y="7929720"/>
            <a:ext cx="1813680" cy="353160"/>
            <a:chOff x="4767840" y="7929720"/>
            <a:chExt cx="1813680" cy="353160"/>
          </a:xfrm>
        </p:grpSpPr>
        <p:sp>
          <p:nvSpPr>
            <p:cNvPr id="87" name="Text Box 68"/>
            <p:cNvSpPr/>
            <p:nvPr/>
          </p:nvSpPr>
          <p:spPr>
            <a:xfrm>
              <a:off x="5103360" y="7929720"/>
              <a:ext cx="781200" cy="353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10  3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Text Box 69"/>
            <p:cNvSpPr/>
            <p:nvPr/>
          </p:nvSpPr>
          <p:spPr>
            <a:xfrm>
              <a:off x="4767840" y="7929720"/>
              <a:ext cx="337680" cy="353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Text Box 70"/>
            <p:cNvSpPr/>
            <p:nvPr/>
          </p:nvSpPr>
          <p:spPr>
            <a:xfrm>
              <a:off x="5936400" y="7929720"/>
              <a:ext cx="337680" cy="353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Text Box 71"/>
            <p:cNvSpPr/>
            <p:nvPr/>
          </p:nvSpPr>
          <p:spPr>
            <a:xfrm>
              <a:off x="6220800" y="7929720"/>
              <a:ext cx="360720" cy="353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M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pic>
        <p:nvPicPr>
          <p:cNvPr id="91" name="Picture 74" descr="Bulk siRNA posit GST SLR1"/>
          <p:cNvPicPr/>
          <p:nvPr/>
        </p:nvPicPr>
        <p:blipFill>
          <a:blip r:embed="rId8">
            <a:lum bright="-12000"/>
          </a:blip>
          <a:srcRect l="21533" t="32700" r="48650" b="43225"/>
          <a:stretch/>
        </p:blipFill>
        <p:spPr>
          <a:xfrm>
            <a:off x="4022640" y="8283600"/>
            <a:ext cx="628560" cy="5698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92" name="Picture 75" descr="bulk siGST"/>
          <p:cNvPicPr/>
          <p:nvPr/>
        </p:nvPicPr>
        <p:blipFill>
          <a:blip r:embed="rId9">
            <a:lum bright="-6000"/>
          </a:blip>
          <a:srcRect l="5760" t="0" r="59453" b="3955"/>
          <a:stretch/>
        </p:blipFill>
        <p:spPr>
          <a:xfrm>
            <a:off x="2854440" y="8283600"/>
            <a:ext cx="1155600" cy="568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93" name="Text Box 77"/>
          <p:cNvSpPr/>
          <p:nvPr/>
        </p:nvSpPr>
        <p:spPr>
          <a:xfrm>
            <a:off x="3201840" y="7929720"/>
            <a:ext cx="78120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700" spc="-1" strike="noStrike">
                <a:solidFill>
                  <a:srgbClr val="000000"/>
                </a:solidFill>
                <a:latin typeface="Arial"/>
              </a:rPr>
              <a:t>10  30</a:t>
            </a: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Text Box 78"/>
          <p:cNvSpPr/>
          <p:nvPr/>
        </p:nvSpPr>
        <p:spPr>
          <a:xfrm>
            <a:off x="2866320" y="7929720"/>
            <a:ext cx="33768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7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Text Box 79"/>
          <p:cNvSpPr/>
          <p:nvPr/>
        </p:nvSpPr>
        <p:spPr>
          <a:xfrm>
            <a:off x="4034880" y="7929720"/>
            <a:ext cx="33768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7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Text Box 80"/>
          <p:cNvSpPr/>
          <p:nvPr/>
        </p:nvSpPr>
        <p:spPr>
          <a:xfrm>
            <a:off x="4319280" y="7929720"/>
            <a:ext cx="36072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7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Text Box 81"/>
          <p:cNvSpPr/>
          <p:nvPr/>
        </p:nvSpPr>
        <p:spPr>
          <a:xfrm>
            <a:off x="1282680" y="7581960"/>
            <a:ext cx="1122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siRNA mix-5’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Text Box 82"/>
          <p:cNvSpPr/>
          <p:nvPr/>
        </p:nvSpPr>
        <p:spPr>
          <a:xfrm>
            <a:off x="3154680" y="7581960"/>
            <a:ext cx="1308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siRNA mix-GS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Text Box 83"/>
          <p:cNvSpPr/>
          <p:nvPr/>
        </p:nvSpPr>
        <p:spPr>
          <a:xfrm>
            <a:off x="5099040" y="7581960"/>
            <a:ext cx="1122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siRNA mix-3’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Text Box 84"/>
          <p:cNvSpPr/>
          <p:nvPr/>
        </p:nvSpPr>
        <p:spPr>
          <a:xfrm>
            <a:off x="231480" y="717876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Line 86"/>
          <p:cNvSpPr/>
          <p:nvPr/>
        </p:nvSpPr>
        <p:spPr>
          <a:xfrm>
            <a:off x="719280" y="8534520"/>
            <a:ext cx="2030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Text Box 87"/>
          <p:cNvSpPr/>
          <p:nvPr/>
        </p:nvSpPr>
        <p:spPr>
          <a:xfrm>
            <a:off x="178560" y="8367840"/>
            <a:ext cx="62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1 nt 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Text Box 288"/>
          <p:cNvSpPr/>
          <p:nvPr/>
        </p:nvSpPr>
        <p:spPr>
          <a:xfrm>
            <a:off x="279360" y="420372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04" name="" descr=""/>
          <p:cNvPicPr/>
          <p:nvPr/>
        </p:nvPicPr>
        <p:blipFill>
          <a:blip r:embed="rId10"/>
          <a:stretch/>
        </p:blipFill>
        <p:spPr>
          <a:xfrm>
            <a:off x="730080" y="4281480"/>
            <a:ext cx="6191280" cy="2589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1-24T12:24:29Z</dcterms:created>
  <dc:creator>breitler</dc:creator>
  <dc:description/>
  <dc:language>en-US</dc:language>
  <cp:lastModifiedBy>GUIDERDONI</cp:lastModifiedBy>
  <cp:lastPrinted>2007-03-29T10:33:38Z</cp:lastPrinted>
  <dcterms:modified xsi:type="dcterms:W3CDTF">2013-01-27T16:09:24Z</dcterms:modified>
  <cp:revision>66</cp:revision>
  <dc:subject/>
  <dc:title>Présentation PowerPoint</dc:title>
</cp:coreProperties>
</file>